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2"/>
  </p:sldMasterIdLst>
  <p:notesMasterIdLst>
    <p:notesMasterId r:id="rId5"/>
  </p:notesMasterIdLst>
  <p:sldIdLst>
    <p:sldId id="272" r:id="rId3"/>
    <p:sldId id="273" r:id="rId4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2A478"/>
    <a:srgbClr val="45A483"/>
    <a:srgbClr val="3F9275"/>
    <a:srgbClr val="2F923D"/>
    <a:srgbClr val="3AB64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31348"/>
    <p:restoredTop sz="85286"/>
  </p:normalViewPr>
  <p:slideViewPr>
    <p:cSldViewPr snapToGrid="0">
      <p:cViewPr varScale="1">
        <p:scale>
          <a:sx n="77" d="100"/>
          <a:sy n="77" d="100"/>
        </p:scale>
        <p:origin x="2088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1.xml"/><Relationship Id="rId7" Type="http://schemas.openxmlformats.org/officeDocument/2006/relationships/viewProps" Target="viewProps.xml"/><Relationship Id="rId2" Type="http://schemas.openxmlformats.org/officeDocument/2006/relationships/slideMaster" Target="slideMasters/slideMaster1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2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23DD5E9-BA8F-F44D-937C-C5AE33658D0E}" type="datetimeFigureOut">
              <a:rPr lang="en-US" smtClean="0"/>
              <a:t>7/28/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EFAB38A-0D3B-214D-A271-6E42B2729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03954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E1C1978-8BC1-1431-8510-376164CC747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C5EB6748-EB9F-04D5-B477-FD478CE64B19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FBF47CB1-E549-B4B1-351B-A556F9221DE8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>
                <a:solidFill>
                  <a:srgbClr val="000000"/>
                </a:solidFill>
                <a:effectLst/>
                <a:latin typeface="Helvetica Neue" panose="02000503000000020004" pitchFamily="2" charset="0"/>
              </a:rPr>
              <a:t>Figure S1. 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D37C780-DFEC-3304-6E34-4E9794A8DE72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EFAB38A-0D3B-214D-A271-6E42B2729CD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199656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9E4DC8E-1F57-454D-4D84-8296A38FF3B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A9E3F998-D9BA-2A65-5EB2-872441B15B16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E5CEC694-EEEF-A31B-3B58-B625F0E06194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>
                <a:solidFill>
                  <a:srgbClr val="000000"/>
                </a:solidFill>
                <a:effectLst/>
                <a:latin typeface="Helvetica Neue" panose="02000503000000020004" pitchFamily="2" charset="0"/>
              </a:rPr>
              <a:t>Figure S2.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="1" dirty="0">
              <a:solidFill>
                <a:srgbClr val="000000"/>
              </a:solidFill>
              <a:effectLst/>
              <a:latin typeface="Helvetica Neue" panose="02000503000000020004" pitchFamily="2" charset="0"/>
            </a:endParaRP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144DDD1-98D8-9992-AFCF-716E452F86B0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EFAB38A-0D3B-214D-A271-6E42B2729CD4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20436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C24B0-9169-794A-B6AD-BEAFC0E68226}" type="datetimeFigureOut">
              <a:rPr lang="en-US" smtClean="0"/>
              <a:t>7/28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37F0C-2715-D644-8D7E-D45A23D5E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37936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C24B0-9169-794A-B6AD-BEAFC0E68226}" type="datetimeFigureOut">
              <a:rPr lang="en-US" smtClean="0"/>
              <a:t>7/28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37F0C-2715-D644-8D7E-D45A23D5E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7707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3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3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C24B0-9169-794A-B6AD-BEAFC0E68226}" type="datetimeFigureOut">
              <a:rPr lang="en-US" smtClean="0"/>
              <a:t>7/28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37F0C-2715-D644-8D7E-D45A23D5E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08827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C24B0-9169-794A-B6AD-BEAFC0E68226}" type="datetimeFigureOut">
              <a:rPr lang="en-US" smtClean="0"/>
              <a:t>7/28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37F0C-2715-D644-8D7E-D45A23D5E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39617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C24B0-9169-794A-B6AD-BEAFC0E68226}" type="datetimeFigureOut">
              <a:rPr lang="en-US" smtClean="0"/>
              <a:t>7/28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37F0C-2715-D644-8D7E-D45A23D5E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45305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C24B0-9169-794A-B6AD-BEAFC0E68226}" type="datetimeFigureOut">
              <a:rPr lang="en-US" smtClean="0"/>
              <a:t>7/28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37F0C-2715-D644-8D7E-D45A23D5E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93691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5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C24B0-9169-794A-B6AD-BEAFC0E68226}" type="datetimeFigureOut">
              <a:rPr lang="en-US" smtClean="0"/>
              <a:t>7/28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37F0C-2715-D644-8D7E-D45A23D5E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20808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C24B0-9169-794A-B6AD-BEAFC0E68226}" type="datetimeFigureOut">
              <a:rPr lang="en-US" smtClean="0"/>
              <a:t>7/28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37F0C-2715-D644-8D7E-D45A23D5E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45778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C24B0-9169-794A-B6AD-BEAFC0E68226}" type="datetimeFigureOut">
              <a:rPr lang="en-US" smtClean="0"/>
              <a:t>7/28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37F0C-2715-D644-8D7E-D45A23D5E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18550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8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C24B0-9169-794A-B6AD-BEAFC0E68226}" type="datetimeFigureOut">
              <a:rPr lang="en-US" smtClean="0"/>
              <a:t>7/28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37F0C-2715-D644-8D7E-D45A23D5E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23017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8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C24B0-9169-794A-B6AD-BEAFC0E68226}" type="datetimeFigureOut">
              <a:rPr lang="en-US" smtClean="0"/>
              <a:t>7/28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37F0C-2715-D644-8D7E-D45A23D5E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94108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0EC24B0-9169-794A-B6AD-BEAFC0E68226}" type="datetimeFigureOut">
              <a:rPr lang="en-US" smtClean="0"/>
              <a:t>7/28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0A37F0C-2715-D644-8D7E-D45A23D5E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69703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2.emf"/><Relationship Id="rId7" Type="http://schemas.microsoft.com/office/2007/relationships/hdphoto" Target="../media/hdphoto2.wdp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microsoft.com/office/2007/relationships/hdphoto" Target="../media/hdphoto1.wdp"/><Relationship Id="rId5" Type="http://schemas.openxmlformats.org/officeDocument/2006/relationships/image" Target="../media/image4.png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B3DA485-607F-2647-5BB6-565B6580EF6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511CB4B2-96D0-9D93-504B-F6EB0E501F58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914" r="12789"/>
          <a:stretch>
            <a:fillRect/>
          </a:stretch>
        </p:blipFill>
        <p:spPr bwMode="auto">
          <a:xfrm>
            <a:off x="73528" y="3061855"/>
            <a:ext cx="5980908" cy="2838202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3CCED8D-3D5A-FB22-8684-4106AB3DDD0F}"/>
              </a:ext>
            </a:extLst>
          </p:cNvPr>
          <p:cNvSpPr txBox="1"/>
          <p:nvPr/>
        </p:nvSpPr>
        <p:spPr>
          <a:xfrm>
            <a:off x="5789123" y="3856802"/>
            <a:ext cx="820133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11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8629F07-2B37-0082-EC9C-F0855BD58F2F}"/>
              </a:ext>
            </a:extLst>
          </p:cNvPr>
          <p:cNvSpPr txBox="1"/>
          <p:nvPr/>
        </p:nvSpPr>
        <p:spPr>
          <a:xfrm>
            <a:off x="525590" y="5540999"/>
            <a:ext cx="5424756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Calibri" panose="020F0502020204030204" pitchFamily="34" charset="0"/>
                <a:cs typeface="Calibri" panose="020F0502020204030204" pitchFamily="34" charset="0"/>
              </a:rPr>
              <a:t>C1    C2   C3   C4   C5   C6   T1   T2   T3    T4   T5   T6   B1   B2   B3   B4   B5   B6  B7   B8 B8.2 B8.3 B9 B10 B11 B12 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EDA953A-C305-02BF-A682-C429C8C7B427}"/>
              </a:ext>
            </a:extLst>
          </p:cNvPr>
          <p:cNvSpPr txBox="1"/>
          <p:nvPr/>
        </p:nvSpPr>
        <p:spPr>
          <a:xfrm>
            <a:off x="570040" y="5771831"/>
            <a:ext cx="5021693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Calibri" panose="020F0502020204030204" pitchFamily="34" charset="0"/>
                <a:cs typeface="Calibri" panose="020F0502020204030204" pitchFamily="34" charset="0"/>
              </a:rPr>
              <a:t>Sample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B23611F-D460-348B-6AD5-C600E38C18B3}"/>
              </a:ext>
            </a:extLst>
          </p:cNvPr>
          <p:cNvSpPr txBox="1"/>
          <p:nvPr/>
        </p:nvSpPr>
        <p:spPr>
          <a:xfrm rot="16200000">
            <a:off x="-1114769" y="4170624"/>
            <a:ext cx="2479146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Calibri" panose="020F0502020204030204" pitchFamily="34" charset="0"/>
                <a:cs typeface="Calibri" panose="020F0502020204030204" pitchFamily="34" charset="0"/>
              </a:rPr>
              <a:t>Read count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18A07B4-6E36-01FD-5BFD-A7FDD4030870}"/>
              </a:ext>
            </a:extLst>
          </p:cNvPr>
          <p:cNvSpPr txBox="1"/>
          <p:nvPr/>
        </p:nvSpPr>
        <p:spPr>
          <a:xfrm>
            <a:off x="6012871" y="4118412"/>
            <a:ext cx="859410" cy="73866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Calibri" panose="020F0502020204030204" pitchFamily="34" charset="0"/>
                <a:cs typeface="Calibri" panose="020F0502020204030204" pitchFamily="34" charset="0"/>
              </a:rPr>
              <a:t>Control</a:t>
            </a:r>
          </a:p>
          <a:p>
            <a:endParaRPr lang="en-US" sz="5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800" dirty="0">
                <a:latin typeface="Calibri" panose="020F0502020204030204" pitchFamily="34" charset="0"/>
                <a:cs typeface="Calibri" panose="020F0502020204030204" pitchFamily="34" charset="0"/>
              </a:rPr>
              <a:t>Tail regenerate</a:t>
            </a:r>
          </a:p>
          <a:p>
            <a:endParaRPr lang="en-US" sz="2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sz="3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800" dirty="0">
                <a:latin typeface="Calibri" panose="020F0502020204030204" pitchFamily="34" charset="0"/>
                <a:cs typeface="Calibri" panose="020F0502020204030204" pitchFamily="34" charset="0"/>
              </a:rPr>
              <a:t>BaCl</a:t>
            </a:r>
            <a:r>
              <a:rPr lang="en-US" sz="800" baseline="-25000" dirty="0">
                <a:latin typeface="Calibri" panose="020F0502020204030204" pitchFamily="34" charset="0"/>
                <a:cs typeface="Calibri" panose="020F0502020204030204" pitchFamily="34" charset="0"/>
              </a:rPr>
              <a:t>2</a:t>
            </a:r>
            <a:r>
              <a:rPr lang="en-US" sz="800" dirty="0">
                <a:latin typeface="Calibri" panose="020F0502020204030204" pitchFamily="34" charset="0"/>
                <a:cs typeface="Calibri" panose="020F0502020204030204" pitchFamily="34" charset="0"/>
              </a:rPr>
              <a:t> –exposed regenerate</a:t>
            </a:r>
          </a:p>
        </p:txBody>
      </p:sp>
    </p:spTree>
    <p:extLst>
      <p:ext uri="{BB962C8B-B14F-4D97-AF65-F5344CB8AC3E}">
        <p14:creationId xmlns:p14="http://schemas.microsoft.com/office/powerpoint/2010/main" val="35280750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78F9823-F689-1EFE-A536-84E4393A711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AA9F7293-0AF2-F52D-72B2-75DF7B84976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1650" t="18495" b="23998"/>
          <a:stretch/>
        </p:blipFill>
        <p:spPr>
          <a:xfrm>
            <a:off x="3728020" y="5657276"/>
            <a:ext cx="3067511" cy="3500062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7BFEEDEE-1020-0107-1737-124274920B7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grayscl/>
          </a:blip>
          <a:srcRect l="16383" t="1844" r="23761"/>
          <a:stretch>
            <a:fillRect/>
          </a:stretch>
        </p:blipFill>
        <p:spPr>
          <a:xfrm>
            <a:off x="28643" y="2797703"/>
            <a:ext cx="3144591" cy="2900598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808F92D0-0B06-70B8-240D-5DB94F21E26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278" t="15916" r="69566" b="28190"/>
          <a:stretch/>
        </p:blipFill>
        <p:spPr>
          <a:xfrm>
            <a:off x="3717180" y="2475503"/>
            <a:ext cx="2959631" cy="3191624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267D66D6-DFA7-80CF-D356-F492B078A60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5342" t="18891" r="36308" b="23601"/>
          <a:stretch/>
        </p:blipFill>
        <p:spPr>
          <a:xfrm>
            <a:off x="60576" y="5812399"/>
            <a:ext cx="2934118" cy="334785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20ACA18A-98F8-6080-3E0D-1D33CC09A438}"/>
              </a:ext>
            </a:extLst>
          </p:cNvPr>
          <p:cNvSpPr txBox="1"/>
          <p:nvPr/>
        </p:nvSpPr>
        <p:spPr>
          <a:xfrm>
            <a:off x="-15180" y="2584519"/>
            <a:ext cx="3529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b="1" dirty="0"/>
              <a:t>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55CB54D-DE2B-EE87-118A-FC529A1F6B99}"/>
              </a:ext>
            </a:extLst>
          </p:cNvPr>
          <p:cNvSpPr txBox="1"/>
          <p:nvPr/>
        </p:nvSpPr>
        <p:spPr>
          <a:xfrm>
            <a:off x="3619091" y="2610495"/>
            <a:ext cx="352923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sz="1600" b="1" dirty="0"/>
              <a:t>c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6B5357A-5D75-4398-C496-7DC8A3C7D3D7}"/>
              </a:ext>
            </a:extLst>
          </p:cNvPr>
          <p:cNvSpPr txBox="1"/>
          <p:nvPr/>
        </p:nvSpPr>
        <p:spPr>
          <a:xfrm>
            <a:off x="22149" y="5957451"/>
            <a:ext cx="352923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sz="1600" b="1" dirty="0"/>
              <a:t>d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7CDB94E-C34F-05D6-FF98-5347DB6A80AD}"/>
              </a:ext>
            </a:extLst>
          </p:cNvPr>
          <p:cNvSpPr txBox="1"/>
          <p:nvPr/>
        </p:nvSpPr>
        <p:spPr>
          <a:xfrm>
            <a:off x="3631453" y="5956870"/>
            <a:ext cx="352923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sz="1600" b="1" dirty="0"/>
              <a:t>e</a:t>
            </a:r>
          </a:p>
        </p:txBody>
      </p:sp>
      <p:sp>
        <p:nvSpPr>
          <p:cNvPr id="16" name="Oval 15">
            <a:extLst>
              <a:ext uri="{FF2B5EF4-FFF2-40B4-BE49-F238E27FC236}">
                <a16:creationId xmlns:a16="http://schemas.microsoft.com/office/drawing/2014/main" id="{AB290484-EAA8-A28E-9417-225E07D51927}"/>
              </a:ext>
            </a:extLst>
          </p:cNvPr>
          <p:cNvSpPr/>
          <p:nvPr/>
        </p:nvSpPr>
        <p:spPr>
          <a:xfrm>
            <a:off x="4488614" y="4545447"/>
            <a:ext cx="104708" cy="86447"/>
          </a:xfrm>
          <a:prstGeom prst="ellipse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7" name="Oval 6">
            <a:extLst>
              <a:ext uri="{FF2B5EF4-FFF2-40B4-BE49-F238E27FC236}">
                <a16:creationId xmlns:a16="http://schemas.microsoft.com/office/drawing/2014/main" id="{ECA916FF-1369-B19A-82DA-4F35D9DC1DB8}"/>
              </a:ext>
            </a:extLst>
          </p:cNvPr>
          <p:cNvSpPr/>
          <p:nvPr/>
        </p:nvSpPr>
        <p:spPr>
          <a:xfrm>
            <a:off x="4918389" y="4529134"/>
            <a:ext cx="104708" cy="86447"/>
          </a:xfrm>
          <a:prstGeom prst="ellipse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18" name="Oval 17">
            <a:extLst>
              <a:ext uri="{FF2B5EF4-FFF2-40B4-BE49-F238E27FC236}">
                <a16:creationId xmlns:a16="http://schemas.microsoft.com/office/drawing/2014/main" id="{00B63505-C991-BE03-E4E4-E8DFABAFA378}"/>
              </a:ext>
            </a:extLst>
          </p:cNvPr>
          <p:cNvSpPr/>
          <p:nvPr/>
        </p:nvSpPr>
        <p:spPr>
          <a:xfrm>
            <a:off x="4429485" y="7780925"/>
            <a:ext cx="104708" cy="86447"/>
          </a:xfrm>
          <a:prstGeom prst="ellipse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19" name="Oval 18">
            <a:extLst>
              <a:ext uri="{FF2B5EF4-FFF2-40B4-BE49-F238E27FC236}">
                <a16:creationId xmlns:a16="http://schemas.microsoft.com/office/drawing/2014/main" id="{13E3A73C-BD5D-58D1-5512-671CB1678B67}"/>
              </a:ext>
            </a:extLst>
          </p:cNvPr>
          <p:cNvSpPr/>
          <p:nvPr/>
        </p:nvSpPr>
        <p:spPr>
          <a:xfrm>
            <a:off x="5246414" y="8065748"/>
            <a:ext cx="104708" cy="86447"/>
          </a:xfrm>
          <a:prstGeom prst="ellipse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20" name="Oval 19">
            <a:extLst>
              <a:ext uri="{FF2B5EF4-FFF2-40B4-BE49-F238E27FC236}">
                <a16:creationId xmlns:a16="http://schemas.microsoft.com/office/drawing/2014/main" id="{797A9B98-C13E-89DB-CD0A-617F2C1D5AD9}"/>
              </a:ext>
            </a:extLst>
          </p:cNvPr>
          <p:cNvSpPr/>
          <p:nvPr/>
        </p:nvSpPr>
        <p:spPr>
          <a:xfrm>
            <a:off x="1301746" y="7919123"/>
            <a:ext cx="104708" cy="86447"/>
          </a:xfrm>
          <a:prstGeom prst="ellipse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21" name="Oval 20">
            <a:extLst>
              <a:ext uri="{FF2B5EF4-FFF2-40B4-BE49-F238E27FC236}">
                <a16:creationId xmlns:a16="http://schemas.microsoft.com/office/drawing/2014/main" id="{7392DF4B-7D3D-43D6-4EC4-9B06C8793511}"/>
              </a:ext>
            </a:extLst>
          </p:cNvPr>
          <p:cNvSpPr/>
          <p:nvPr/>
        </p:nvSpPr>
        <p:spPr>
          <a:xfrm>
            <a:off x="2600273" y="8303094"/>
            <a:ext cx="104708" cy="86447"/>
          </a:xfrm>
          <a:prstGeom prst="ellipse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D077AB1-40EA-F913-2654-D13B3EB2B576}"/>
              </a:ext>
            </a:extLst>
          </p:cNvPr>
          <p:cNvSpPr txBox="1"/>
          <p:nvPr/>
        </p:nvSpPr>
        <p:spPr>
          <a:xfrm>
            <a:off x="4190225" y="5129407"/>
            <a:ext cx="344268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600" dirty="0"/>
              <a:t>G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332028C-19E3-10DA-5DBD-9D5B4667160D}"/>
              </a:ext>
            </a:extLst>
          </p:cNvPr>
          <p:cNvSpPr txBox="1"/>
          <p:nvPr/>
        </p:nvSpPr>
        <p:spPr>
          <a:xfrm>
            <a:off x="6260858" y="5129407"/>
            <a:ext cx="373730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600" dirty="0"/>
              <a:t>S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C50FAEB-6EC2-FF00-F82A-0F6B8FA5FC80}"/>
              </a:ext>
            </a:extLst>
          </p:cNvPr>
          <p:cNvSpPr txBox="1"/>
          <p:nvPr/>
        </p:nvSpPr>
        <p:spPr>
          <a:xfrm>
            <a:off x="621801" y="8453672"/>
            <a:ext cx="34426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/>
              <a:t>G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EAC1CF2-3407-F77D-5F90-EE0C8F5ADA58}"/>
              </a:ext>
            </a:extLst>
          </p:cNvPr>
          <p:cNvSpPr txBox="1"/>
          <p:nvPr/>
        </p:nvSpPr>
        <p:spPr>
          <a:xfrm>
            <a:off x="4155779" y="8382734"/>
            <a:ext cx="344268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600" dirty="0"/>
              <a:t>G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A4BFF64-821C-F543-F45B-EBDD4CE8229D}"/>
              </a:ext>
            </a:extLst>
          </p:cNvPr>
          <p:cNvSpPr txBox="1"/>
          <p:nvPr/>
        </p:nvSpPr>
        <p:spPr>
          <a:xfrm>
            <a:off x="2548432" y="8442256"/>
            <a:ext cx="37373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/>
              <a:t>S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26BCCBE-62E5-AE0A-5A18-33B702D546AA}"/>
              </a:ext>
            </a:extLst>
          </p:cNvPr>
          <p:cNvSpPr txBox="1"/>
          <p:nvPr/>
        </p:nvSpPr>
        <p:spPr>
          <a:xfrm>
            <a:off x="6332543" y="8405883"/>
            <a:ext cx="344268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600" dirty="0"/>
              <a:t>S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4B68DDF1-4314-7318-5CF8-F6FC79FB6D2C}"/>
              </a:ext>
            </a:extLst>
          </p:cNvPr>
          <p:cNvSpPr/>
          <p:nvPr/>
        </p:nvSpPr>
        <p:spPr>
          <a:xfrm>
            <a:off x="3584864" y="2475503"/>
            <a:ext cx="378495" cy="26769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3" name="Picture 2" descr="usascientific.com">
            <a:extLst>
              <a:ext uri="{FF2B5EF4-FFF2-40B4-BE49-F238E27FC236}">
                <a16:creationId xmlns:a16="http://schemas.microsoft.com/office/drawing/2014/main" id="{4B266285-1ADA-0C79-3582-38C1F682841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ackgroundRemoval t="10000" b="90000" l="2857" r="95143">
                        <a14:foregroundMark x1="88286" y1="41143" x2="91714" y2="54286"/>
                        <a14:foregroundMark x1="5714" y1="40286" x2="8286" y2="57143"/>
                        <a14:foregroundMark x1="38857" y1="78000" x2="55143" y2="75143"/>
                        <a14:foregroundMark x1="94000" y1="43143" x2="95143" y2="52286"/>
                        <a14:foregroundMark x1="2857" y1="57714" x2="2857" y2="48571"/>
                      </a14:backgroundRemoval>
                    </a14:imgEffect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0286" y="-125022"/>
            <a:ext cx="923544" cy="92354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4" name="Picture 23" descr="usascientific.com">
            <a:extLst>
              <a:ext uri="{FF2B5EF4-FFF2-40B4-BE49-F238E27FC236}">
                <a16:creationId xmlns:a16="http://schemas.microsoft.com/office/drawing/2014/main" id="{51969352-45B8-3876-7374-F2DCBD7AE98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ackgroundRemoval t="10000" b="90000" l="2857" r="95143">
                        <a14:foregroundMark x1="88286" y1="41143" x2="91714" y2="54286"/>
                        <a14:foregroundMark x1="5714" y1="40286" x2="8286" y2="57143"/>
                        <a14:foregroundMark x1="38857" y1="78000" x2="55143" y2="75143"/>
                        <a14:foregroundMark x1="94000" y1="43143" x2="95143" y2="52286"/>
                        <a14:foregroundMark x1="2857" y1="57714" x2="2857" y2="48571"/>
                      </a14:backgroundRemoval>
                    </a14:imgEffect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9252" y="1244240"/>
            <a:ext cx="960120" cy="9601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E4333C82-2842-6B65-6AFC-955AD618DCD2}"/>
              </a:ext>
            </a:extLst>
          </p:cNvPr>
          <p:cNvSpPr txBox="1"/>
          <p:nvPr/>
        </p:nvSpPr>
        <p:spPr>
          <a:xfrm>
            <a:off x="1420553" y="1563491"/>
            <a:ext cx="4320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X 3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1B7705A-1C61-DBD9-C392-11B9B06EE22B}"/>
              </a:ext>
            </a:extLst>
          </p:cNvPr>
          <p:cNvSpPr txBox="1"/>
          <p:nvPr/>
        </p:nvSpPr>
        <p:spPr>
          <a:xfrm>
            <a:off x="527644" y="1518664"/>
            <a:ext cx="103508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30 planaria </a:t>
            </a:r>
          </a:p>
          <a:p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in 1mM BaCl</a:t>
            </a:r>
            <a:r>
              <a:rPr lang="en-US" sz="1000" baseline="-25000" dirty="0">
                <a:latin typeface="Calibri" panose="020F0502020204030204" pitchFamily="34" charset="0"/>
                <a:cs typeface="Calibri" panose="020F0502020204030204" pitchFamily="34" charset="0"/>
              </a:rPr>
              <a:t>2</a:t>
            </a:r>
            <a:endParaRPr lang="en-US" sz="10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03488250-8CAC-BAEA-7870-AF49B7B31167}"/>
              </a:ext>
            </a:extLst>
          </p:cNvPr>
          <p:cNvSpPr txBox="1"/>
          <p:nvPr/>
        </p:nvSpPr>
        <p:spPr>
          <a:xfrm>
            <a:off x="477529" y="159474"/>
            <a:ext cx="99117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1 planaria </a:t>
            </a:r>
          </a:p>
          <a:p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in 1mM BaCl</a:t>
            </a:r>
            <a:r>
              <a:rPr lang="en-US" sz="1000" baseline="-25000" dirty="0">
                <a:latin typeface="Calibri" panose="020F0502020204030204" pitchFamily="34" charset="0"/>
                <a:cs typeface="Calibri" panose="020F0502020204030204" pitchFamily="34" charset="0"/>
              </a:rPr>
              <a:t>2</a:t>
            </a:r>
            <a:endParaRPr lang="en-US" sz="10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CDB09D73-A651-901A-3461-C23D043F9EB8}"/>
              </a:ext>
            </a:extLst>
          </p:cNvPr>
          <p:cNvSpPr txBox="1"/>
          <p:nvPr/>
        </p:nvSpPr>
        <p:spPr>
          <a:xfrm>
            <a:off x="1391877" y="221201"/>
            <a:ext cx="4320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X 10</a:t>
            </a:r>
          </a:p>
        </p:txBody>
      </p: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C643F062-5AC2-2640-D6E9-00BF7934B5AD}"/>
              </a:ext>
            </a:extLst>
          </p:cNvPr>
          <p:cNvCxnSpPr/>
          <p:nvPr/>
        </p:nvCxnSpPr>
        <p:spPr>
          <a:xfrm>
            <a:off x="1711742" y="1121666"/>
            <a:ext cx="493776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CB6E1F4A-DAA5-6C55-F9CB-0F881764D6B8}"/>
              </a:ext>
            </a:extLst>
          </p:cNvPr>
          <p:cNvSpPr txBox="1"/>
          <p:nvPr/>
        </p:nvSpPr>
        <p:spPr>
          <a:xfrm>
            <a:off x="1256150" y="685384"/>
            <a:ext cx="155299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Calibri" panose="020F0502020204030204" pitchFamily="34" charset="0"/>
                <a:cs typeface="Calibri" panose="020F0502020204030204" pitchFamily="34" charset="0"/>
              </a:rPr>
              <a:t>refresh liquid in all dishes every day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E6629FD5-20D7-AB78-9A3E-8490B8434780}"/>
              </a:ext>
            </a:extLst>
          </p:cNvPr>
          <p:cNvSpPr txBox="1"/>
          <p:nvPr/>
        </p:nvSpPr>
        <p:spPr>
          <a:xfrm>
            <a:off x="2776260" y="899545"/>
            <a:ext cx="182314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Calibri" panose="020F0502020204030204" pitchFamily="34" charset="0"/>
                <a:cs typeface="Calibri" panose="020F0502020204030204" pitchFamily="34" charset="0"/>
              </a:rPr>
              <a:t>day 16: extract RNA from the regenerated planaria</a:t>
            </a:r>
          </a:p>
        </p:txBody>
      </p: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834DF1E1-F312-523B-C287-9A874E3964BE}"/>
              </a:ext>
            </a:extLst>
          </p:cNvPr>
          <p:cNvCxnSpPr>
            <a:cxnSpLocks/>
          </p:cNvCxnSpPr>
          <p:nvPr/>
        </p:nvCxnSpPr>
        <p:spPr>
          <a:xfrm>
            <a:off x="4546086" y="1080603"/>
            <a:ext cx="457142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ABC1E334-2916-3913-7BFF-73ACC6F4009B}"/>
              </a:ext>
            </a:extLst>
          </p:cNvPr>
          <p:cNvSpPr txBox="1"/>
          <p:nvPr/>
        </p:nvSpPr>
        <p:spPr>
          <a:xfrm>
            <a:off x="5183397" y="922406"/>
            <a:ext cx="1428719" cy="4308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 err="1">
                <a:latin typeface="Calibri" panose="020F0502020204030204" pitchFamily="34" charset="0"/>
                <a:cs typeface="Calibri" panose="020F0502020204030204" pitchFamily="34" charset="0"/>
              </a:rPr>
              <a:t>RNAseq</a:t>
            </a:r>
            <a:r>
              <a:rPr lang="en-US" sz="1100" dirty="0">
                <a:latin typeface="Calibri" panose="020F0502020204030204" pitchFamily="34" charset="0"/>
                <a:cs typeface="Calibri" panose="020F0502020204030204" pitchFamily="34" charset="0"/>
              </a:rPr>
              <a:t> of mRNAs using Illumina</a:t>
            </a:r>
          </a:p>
        </p:txBody>
      </p:sp>
      <p:pic>
        <p:nvPicPr>
          <p:cNvPr id="34" name="Picture 2" descr="usascientific.com">
            <a:extLst>
              <a:ext uri="{FF2B5EF4-FFF2-40B4-BE49-F238E27FC236}">
                <a16:creationId xmlns:a16="http://schemas.microsoft.com/office/drawing/2014/main" id="{64CA2900-BED9-42E6-92E3-7E9DE3E5F40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ackgroundRemoval t="10000" b="90000" l="2857" r="95143">
                        <a14:foregroundMark x1="88286" y1="41143" x2="91714" y2="54286"/>
                        <a14:foregroundMark x1="5714" y1="40286" x2="8286" y2="57143"/>
                        <a14:foregroundMark x1="38857" y1="78000" x2="55143" y2="75143"/>
                        <a14:foregroundMark x1="94000" y1="43143" x2="95143" y2="52286"/>
                        <a14:foregroundMark x1="2857" y1="57714" x2="2857" y2="48571"/>
                      </a14:backgroundRemoval>
                    </a14:imgEffect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4092" y="-134142"/>
            <a:ext cx="960120" cy="9601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553EE337-01E7-6F15-3B19-B007B6AFE5DE}"/>
              </a:ext>
            </a:extLst>
          </p:cNvPr>
          <p:cNvSpPr txBox="1"/>
          <p:nvPr/>
        </p:nvSpPr>
        <p:spPr>
          <a:xfrm>
            <a:off x="3082026" y="86687"/>
            <a:ext cx="1228793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1 regenerated planaria </a:t>
            </a:r>
          </a:p>
          <a:p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in 1mM BaCl</a:t>
            </a:r>
            <a:r>
              <a:rPr lang="en-US" sz="1000" baseline="-25000" dirty="0">
                <a:latin typeface="Calibri" panose="020F0502020204030204" pitchFamily="34" charset="0"/>
                <a:cs typeface="Calibri" panose="020F0502020204030204" pitchFamily="34" charset="0"/>
              </a:rPr>
              <a:t>2</a:t>
            </a:r>
            <a:endParaRPr lang="en-US" sz="10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5B1F7BFA-012F-031D-0076-9137EE8CD0AF}"/>
              </a:ext>
            </a:extLst>
          </p:cNvPr>
          <p:cNvSpPr txBox="1"/>
          <p:nvPr/>
        </p:nvSpPr>
        <p:spPr>
          <a:xfrm>
            <a:off x="4132889" y="224236"/>
            <a:ext cx="4320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X 3</a:t>
            </a:r>
          </a:p>
        </p:txBody>
      </p:sp>
      <p:pic>
        <p:nvPicPr>
          <p:cNvPr id="37" name="Picture 2" descr="usascientific.com">
            <a:extLst>
              <a:ext uri="{FF2B5EF4-FFF2-40B4-BE49-F238E27FC236}">
                <a16:creationId xmlns:a16="http://schemas.microsoft.com/office/drawing/2014/main" id="{B5621FCA-32F8-A3CC-7029-438BC008E8C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ackgroundRemoval t="10000" b="90000" l="2857" r="95143">
                        <a14:foregroundMark x1="88286" y1="41143" x2="91714" y2="54286"/>
                        <a14:foregroundMark x1="5714" y1="40286" x2="8286" y2="57143"/>
                        <a14:foregroundMark x1="38857" y1="78000" x2="55143" y2="75143"/>
                        <a14:foregroundMark x1="94000" y1="43143" x2="95143" y2="52286"/>
                        <a14:foregroundMark x1="2857" y1="57714" x2="2857" y2="48571"/>
                      </a14:backgroundRemoval>
                    </a14:imgEffect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23801" y="1290242"/>
            <a:ext cx="960120" cy="9601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8" name="TextBox 37">
            <a:extLst>
              <a:ext uri="{FF2B5EF4-FFF2-40B4-BE49-F238E27FC236}">
                <a16:creationId xmlns:a16="http://schemas.microsoft.com/office/drawing/2014/main" id="{F2F3F69E-5B03-84EB-2A8B-8DD0699CEDF0}"/>
              </a:ext>
            </a:extLst>
          </p:cNvPr>
          <p:cNvSpPr txBox="1"/>
          <p:nvPr/>
        </p:nvSpPr>
        <p:spPr>
          <a:xfrm>
            <a:off x="4205448" y="1611884"/>
            <a:ext cx="4320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X 3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3479C531-3B1C-B0BD-B977-0A4A217578EC}"/>
              </a:ext>
            </a:extLst>
          </p:cNvPr>
          <p:cNvSpPr txBox="1"/>
          <p:nvPr/>
        </p:nvSpPr>
        <p:spPr>
          <a:xfrm>
            <a:off x="3112030" y="1477608"/>
            <a:ext cx="1236886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4 regenerated planaria in 1mM BaCl</a:t>
            </a:r>
            <a:r>
              <a:rPr lang="en-US" sz="1000" baseline="-25000" dirty="0">
                <a:latin typeface="Calibri" panose="020F0502020204030204" pitchFamily="34" charset="0"/>
                <a:cs typeface="Calibri" panose="020F0502020204030204" pitchFamily="34" charset="0"/>
              </a:rPr>
              <a:t>2</a:t>
            </a:r>
            <a:endParaRPr lang="en-US" sz="10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491C2033-1A18-292E-07D5-364A928ECEB7}"/>
              </a:ext>
            </a:extLst>
          </p:cNvPr>
          <p:cNvSpPr txBox="1"/>
          <p:nvPr/>
        </p:nvSpPr>
        <p:spPr>
          <a:xfrm>
            <a:off x="26244" y="7846"/>
            <a:ext cx="3529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b="1" dirty="0"/>
              <a:t>a</a:t>
            </a: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FC4D13C4-5272-4616-DB09-C4554DA24625}"/>
              </a:ext>
            </a:extLst>
          </p:cNvPr>
          <p:cNvSpPr/>
          <p:nvPr/>
        </p:nvSpPr>
        <p:spPr>
          <a:xfrm>
            <a:off x="-15180" y="5596552"/>
            <a:ext cx="542824" cy="37539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12989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item1.xml><?xml version="1.0" encoding="utf-8"?>
<LabArchives xmlns:xsi="http://www.w3.org/2001/XMLSchema-instance" xmlns:xsd="http://www.w3.org/2001/XMLSchema">
  <BaseUri>https://mynotebook.labarchives.com</BaseUri>
  <eid>MjE4LjR8OTQ5MDMxLzE2OC9FbnRyeVBhcnQvMjAxNTcyMTI5MHw1NTQuNA==</eid>
  <version>1</version>
  <updated-at>2024-07-18T15:14:03Z</updated-at>
</LabArchives>
</file>

<file path=customXml/itemProps1.xml><?xml version="1.0" encoding="utf-8"?>
<ds:datastoreItem xmlns:ds="http://schemas.openxmlformats.org/officeDocument/2006/customXml" ds:itemID="{5959E213-B30A-414A-9C1F-AD79CC3F5964}">
  <ds:schemaRefs>
    <ds:schemaRef ds:uri="http://www.w3.org/2001/XMLSchema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562</TotalTime>
  <Words>106</Words>
  <Application>Microsoft Macintosh PowerPoint</Application>
  <PresentationFormat>On-screen Show (4:3)</PresentationFormat>
  <Paragraphs>38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ptos</vt:lpstr>
      <vt:lpstr>Aptos Display</vt:lpstr>
      <vt:lpstr>Arial</vt:lpstr>
      <vt:lpstr>Calibri</vt:lpstr>
      <vt:lpstr>Helvetica Neue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apsetaki, Stefania Elisavet</dc:creator>
  <cp:lastModifiedBy>Gotch, Tomika</cp:lastModifiedBy>
  <cp:revision>133</cp:revision>
  <cp:lastPrinted>2025-04-29T14:51:40Z</cp:lastPrinted>
  <dcterms:created xsi:type="dcterms:W3CDTF">2024-07-18T14:42:07Z</dcterms:created>
  <dcterms:modified xsi:type="dcterms:W3CDTF">2026-07-28T17:28:18Z</dcterms:modified>
</cp:coreProperties>
</file>